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70" r:id="rId2"/>
    <p:sldId id="271" r:id="rId3"/>
    <p:sldId id="281" r:id="rId4"/>
    <p:sldId id="272" r:id="rId5"/>
    <p:sldId id="282" r:id="rId6"/>
    <p:sldId id="283" r:id="rId7"/>
    <p:sldId id="284" r:id="rId8"/>
    <p:sldId id="285" r:id="rId9"/>
    <p:sldId id="286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6" d="100"/>
          <a:sy n="96" d="100"/>
        </p:scale>
        <p:origin x="-2344" y="-1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notesMaster" Target="notesMasters/notesMaster1.xml"/><Relationship Id="rId12" Type="http://schemas.openxmlformats.org/officeDocument/2006/relationships/printerSettings" Target="printerSettings/printerSettings1.bin"/><Relationship Id="rId13" Type="http://schemas.openxmlformats.org/officeDocument/2006/relationships/presProps" Target="presProps.xml"/><Relationship Id="rId14" Type="http://schemas.openxmlformats.org/officeDocument/2006/relationships/viewProps" Target="viewProps.xml"/><Relationship Id="rId15" Type="http://schemas.openxmlformats.org/officeDocument/2006/relationships/theme" Target="theme/them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300027-3176-4B2F-911E-6FE57ED40DA7}" type="datetimeFigureOut">
              <a:rPr lang="en-US" smtClean="0"/>
              <a:t>5/12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ECDB30-8BB4-4E48-9760-4D1D1CA61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59336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DECDB30-8BB4-4E48-9760-4D1D1CA614E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94816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DECDB30-8BB4-4E48-9760-4D1D1CA614E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665478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DECDB30-8BB4-4E48-9760-4D1D1CA614EB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12536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DECDB30-8BB4-4E48-9760-4D1D1CA614EB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10292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1412C-A0CE-4341-9957-CD8F5AD04188}" type="datetimeFigureOut">
              <a:rPr lang="en-US" smtClean="0"/>
              <a:t>5/1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30CEF-FFB8-448E-8B3C-AF02B3788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9639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1412C-A0CE-4341-9957-CD8F5AD04188}" type="datetimeFigureOut">
              <a:rPr lang="en-US" smtClean="0"/>
              <a:t>5/1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30CEF-FFB8-448E-8B3C-AF02B3788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2429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1412C-A0CE-4341-9957-CD8F5AD04188}" type="datetimeFigureOut">
              <a:rPr lang="en-US" smtClean="0"/>
              <a:t>5/1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30CEF-FFB8-448E-8B3C-AF02B3788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03615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1412C-A0CE-4341-9957-CD8F5AD04188}" type="datetimeFigureOut">
              <a:rPr lang="en-US" smtClean="0"/>
              <a:t>5/1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30CEF-FFB8-448E-8B3C-AF02B3788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4382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1412C-A0CE-4341-9957-CD8F5AD04188}" type="datetimeFigureOut">
              <a:rPr lang="en-US" smtClean="0"/>
              <a:t>5/1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30CEF-FFB8-448E-8B3C-AF02B3788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43792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1412C-A0CE-4341-9957-CD8F5AD04188}" type="datetimeFigureOut">
              <a:rPr lang="en-US" smtClean="0"/>
              <a:t>5/1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30CEF-FFB8-448E-8B3C-AF02B3788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7705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1412C-A0CE-4341-9957-CD8F5AD04188}" type="datetimeFigureOut">
              <a:rPr lang="en-US" smtClean="0"/>
              <a:t>5/12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30CEF-FFB8-448E-8B3C-AF02B3788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7440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1412C-A0CE-4341-9957-CD8F5AD04188}" type="datetimeFigureOut">
              <a:rPr lang="en-US" smtClean="0"/>
              <a:t>5/12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30CEF-FFB8-448E-8B3C-AF02B3788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653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1412C-A0CE-4341-9957-CD8F5AD04188}" type="datetimeFigureOut">
              <a:rPr lang="en-US" smtClean="0"/>
              <a:t>5/12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30CEF-FFB8-448E-8B3C-AF02B3788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1007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1412C-A0CE-4341-9957-CD8F5AD04188}" type="datetimeFigureOut">
              <a:rPr lang="en-US" smtClean="0"/>
              <a:t>5/1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30CEF-FFB8-448E-8B3C-AF02B3788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098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1412C-A0CE-4341-9957-CD8F5AD04188}" type="datetimeFigureOut">
              <a:rPr lang="en-US" smtClean="0"/>
              <a:t>5/1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30CEF-FFB8-448E-8B3C-AF02B3788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0414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C1412C-A0CE-4341-9957-CD8F5AD04188}" type="datetimeFigureOut">
              <a:rPr lang="en-US" smtClean="0"/>
              <a:t>5/1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D30CEF-FFB8-448E-8B3C-AF02B3788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8121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Content Placeholder 6" descr="gwas2_ssr_p_fdr_gw_FAT.png"/>
          <p:cNvPicPr>
            <a:picLocks noGrp="1" noChangeAspect="1"/>
          </p:cNvPicPr>
          <p:nvPr>
            <p:ph idx="1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558" r="-4558"/>
          <a:stretch>
            <a:fillRect/>
          </a:stretch>
        </p:blipFill>
        <p:spPr/>
      </p:pic>
      <p:sp>
        <p:nvSpPr>
          <p:cNvPr id="6" name="TextBox 5"/>
          <p:cNvSpPr txBox="1"/>
          <p:nvPr/>
        </p:nvSpPr>
        <p:spPr>
          <a:xfrm>
            <a:off x="194383" y="213775"/>
            <a:ext cx="1101492" cy="3693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/>
              <a:t>1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04800" y="62126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0126530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Content Placeholder 9" descr="gwas2_ssr_p_fdr_gw_FATD.png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558" r="-4558"/>
          <a:stretch>
            <a:fillRect/>
          </a:stretch>
        </p:blipFill>
        <p:spPr/>
      </p:pic>
      <p:sp>
        <p:nvSpPr>
          <p:cNvPr id="5" name="TextBox 4"/>
          <p:cNvSpPr txBox="1"/>
          <p:nvPr/>
        </p:nvSpPr>
        <p:spPr>
          <a:xfrm>
            <a:off x="194383" y="213775"/>
            <a:ext cx="1101492" cy="3693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/>
              <a:t>1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04800" y="62126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2664008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Content Placeholder 6" descr="gwas2_ssr_p_fdr_gw_PROT.png"/>
          <p:cNvPicPr>
            <a:picLocks noGrp="1" noChangeAspect="1"/>
          </p:cNvPicPr>
          <p:nvPr>
            <p:ph idx="1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558" r="-4558"/>
          <a:stretch>
            <a:fillRect/>
          </a:stretch>
        </p:blipFill>
        <p:spPr/>
      </p:pic>
      <p:sp>
        <p:nvSpPr>
          <p:cNvPr id="6" name="TextBox 5"/>
          <p:cNvSpPr txBox="1"/>
          <p:nvPr/>
        </p:nvSpPr>
        <p:spPr>
          <a:xfrm>
            <a:off x="194383" y="213775"/>
            <a:ext cx="1101492" cy="3693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/>
              <a:t>1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04800" y="62126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3828028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Content Placeholder 8" descr="gwas2_ssr_p_fdr_gw_PROTD.png"/>
          <p:cNvPicPr>
            <a:picLocks noGrp="1" noChangeAspect="1"/>
          </p:cNvPicPr>
          <p:nvPr>
            <p:ph idx="1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558" r="-4558"/>
          <a:stretch>
            <a:fillRect/>
          </a:stretch>
        </p:blipFill>
        <p:spPr/>
      </p:pic>
      <p:sp>
        <p:nvSpPr>
          <p:cNvPr id="7" name="TextBox 6"/>
          <p:cNvSpPr txBox="1"/>
          <p:nvPr/>
        </p:nvSpPr>
        <p:spPr>
          <a:xfrm>
            <a:off x="194383" y="213775"/>
            <a:ext cx="1101492" cy="3693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/>
              <a:t>1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04800" y="62126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9862384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gwas2_ssr3_p_qq_MILK.png"/>
          <p:cNvPicPr>
            <a:picLocks noGrp="1" noChangeAspect="1"/>
          </p:cNvPicPr>
          <p:nvPr>
            <p:ph idx="1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0915" r="-40915"/>
          <a:stretch>
            <a:fillRect/>
          </a:stretch>
        </p:blipFill>
        <p:spPr/>
      </p:pic>
      <p:sp>
        <p:nvSpPr>
          <p:cNvPr id="6" name="TextBox 5"/>
          <p:cNvSpPr txBox="1"/>
          <p:nvPr/>
        </p:nvSpPr>
        <p:spPr>
          <a:xfrm>
            <a:off x="194383" y="213775"/>
            <a:ext cx="1101492" cy="3693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/>
              <a:t>1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04800" y="62126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7839562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Content Placeholder 6" descr="gwas2_ssr3_p_qq_FAT.png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0915" r="-40915"/>
          <a:stretch>
            <a:fillRect/>
          </a:stretch>
        </p:blipFill>
        <p:spPr/>
      </p:pic>
      <p:sp>
        <p:nvSpPr>
          <p:cNvPr id="6" name="TextBox 5"/>
          <p:cNvSpPr txBox="1"/>
          <p:nvPr/>
        </p:nvSpPr>
        <p:spPr>
          <a:xfrm>
            <a:off x="194383" y="213775"/>
            <a:ext cx="1101492" cy="3693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/>
              <a:t>1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04799" y="621268"/>
            <a:ext cx="4403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9823407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Content Placeholder 6" descr="gwas2_ssr3_p_qq_FATD.png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0915" r="-40915"/>
          <a:stretch>
            <a:fillRect/>
          </a:stretch>
        </p:blipFill>
        <p:spPr/>
      </p:pic>
      <p:sp>
        <p:nvSpPr>
          <p:cNvPr id="6" name="TextBox 5"/>
          <p:cNvSpPr txBox="1"/>
          <p:nvPr/>
        </p:nvSpPr>
        <p:spPr>
          <a:xfrm>
            <a:off x="194383" y="213775"/>
            <a:ext cx="1101492" cy="3693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/>
              <a:t>1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04799" y="621268"/>
            <a:ext cx="4403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8280917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Content Placeholder 6" descr="gwas2_ssr3_p_qq_PROT.png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0915" r="-40915"/>
          <a:stretch>
            <a:fillRect/>
          </a:stretch>
        </p:blipFill>
        <p:spPr/>
      </p:pic>
      <p:sp>
        <p:nvSpPr>
          <p:cNvPr id="6" name="TextBox 5"/>
          <p:cNvSpPr txBox="1"/>
          <p:nvPr/>
        </p:nvSpPr>
        <p:spPr>
          <a:xfrm>
            <a:off x="194383" y="213775"/>
            <a:ext cx="1101492" cy="3693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/>
              <a:t>1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04800" y="62126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6095850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Content Placeholder 6" descr="gwas2_ssr3_p_qq_PROTD.png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0915" r="-40915"/>
          <a:stretch>
            <a:fillRect/>
          </a:stretch>
        </p:blipFill>
        <p:spPr/>
      </p:pic>
      <p:sp>
        <p:nvSpPr>
          <p:cNvPr id="6" name="TextBox 5"/>
          <p:cNvSpPr txBox="1"/>
          <p:nvPr/>
        </p:nvSpPr>
        <p:spPr>
          <a:xfrm>
            <a:off x="194383" y="213775"/>
            <a:ext cx="1101492" cy="3693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/>
              <a:t>1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04800" y="62126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883831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6</TotalTime>
  <Words>40</Words>
  <Application>Microsoft Macintosh PowerPoint</Application>
  <PresentationFormat>On-screen Show (4:3)</PresentationFormat>
  <Paragraphs>22</Paragraphs>
  <Slides>9</Slides>
  <Notes>4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of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yeri, Shadi</dc:creator>
  <cp:lastModifiedBy>Shadi Nayeri</cp:lastModifiedBy>
  <cp:revision>28</cp:revision>
  <dcterms:created xsi:type="dcterms:W3CDTF">2015-06-07T02:36:43Z</dcterms:created>
  <dcterms:modified xsi:type="dcterms:W3CDTF">2016-05-12T22:25:13Z</dcterms:modified>
</cp:coreProperties>
</file>